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FA997-965E-467A-851B-D59FE29441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1F443-6DCF-46CC-9934-C9335A95CA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CD7DF-CD56-4B67-9230-B6DB7505DC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361C2-37C7-46FD-BF94-E9D7E43FFF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3D4B2-8EAC-4C81-9551-8747635C2E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DED88-3DB4-4B2C-BCFD-223C520944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3913E-4D72-47BA-8C8D-F481FC1BC7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9EBA3-C260-4C4A-86AE-87279B96D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84451-FBF4-472B-922A-D3DF08DDF5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76E09-1B1F-4A1D-99AF-BF2C36C27B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30E9A-FD3B-4D14-A54C-A563EE2E0D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F90C1-DA89-4434-B069-8950D80282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8560" y="272880"/>
            <a:ext cx="313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, Additional data file 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981000" y="2193840"/>
            <a:ext cx="1776600" cy="20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" descr=""/>
          <p:cNvPicPr/>
          <p:nvPr/>
        </p:nvPicPr>
        <p:blipFill>
          <a:blip r:embed="rId2"/>
          <a:srcRect l="27272" t="0" r="29528" b="24743"/>
          <a:stretch/>
        </p:blipFill>
        <p:spPr>
          <a:xfrm>
            <a:off x="2925720" y="2193840"/>
            <a:ext cx="863640" cy="20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" descr=""/>
          <p:cNvPicPr/>
          <p:nvPr/>
        </p:nvPicPr>
        <p:blipFill>
          <a:blip r:embed="rId3">
            <a:lum bright="6000"/>
          </a:blip>
          <a:stretch/>
        </p:blipFill>
        <p:spPr>
          <a:xfrm>
            <a:off x="981000" y="4714920"/>
            <a:ext cx="1657440" cy="2017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5" name="" descr=""/>
          <p:cNvPicPr/>
          <p:nvPr/>
        </p:nvPicPr>
        <p:blipFill>
          <a:blip r:embed="rId4">
            <a:lum bright="6000"/>
          </a:blip>
          <a:stretch/>
        </p:blipFill>
        <p:spPr>
          <a:xfrm>
            <a:off x="3645000" y="4716360"/>
            <a:ext cx="1655640" cy="20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" name=""/>
          <p:cNvSpPr/>
          <p:nvPr/>
        </p:nvSpPr>
        <p:spPr>
          <a:xfrm>
            <a:off x="551160" y="2193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51160" y="4572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214800" y="4572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76280" y="899280"/>
            <a:ext cx="5832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data file 8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uality control analyses of samples prior to microarray analysis. Representative photomicrographs are shown for Agilent Lab-on-a-chip analysis of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purified hepatic RNA;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biotinylated cRNA;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chemically fragmented cRNA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8D9E8-0EB8-4553-B896-B22DA5F5012A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16T09:17:31Z</dcterms:created>
  <dc:creator>verschl</dc:creator>
  <dc:description/>
  <dc:language>en-US</dc:language>
  <cp:lastModifiedBy>kleemannr</cp:lastModifiedBy>
  <dcterms:modified xsi:type="dcterms:W3CDTF">2007-07-13T09:52:59Z</dcterms:modified>
  <cp:revision>120</cp:revision>
  <dc:subject/>
  <dc:title>Dia 1</dc:title>
</cp:coreProperties>
</file>